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  <p:sldId id="265" r:id="rId4"/>
    <p:sldId id="257" r:id="rId5"/>
    <p:sldId id="258" r:id="rId6"/>
    <p:sldId id="256" r:id="rId7"/>
    <p:sldId id="260" r:id="rId8"/>
    <p:sldId id="261" r:id="rId9"/>
    <p:sldId id="259" r:id="rId10"/>
    <p:sldId id="262" r:id="rId11"/>
    <p:sldId id="266" r:id="rId12"/>
    <p:sldId id="267" r:id="rId13"/>
    <p:sldId id="326" r:id="rId1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138" d="100"/>
          <a:sy n="138" d="100"/>
        </p:scale>
        <p:origin x="192" y="7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637339-E368-4BF6-A9DA-5FFF799B2D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D679F5D-7F6B-43C1-A077-1B68F2F305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FF6D49-CF18-422B-88A3-72F792AF8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DB82CA5-3EAA-43AD-A7D9-8EF9B6119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EC71C6-0507-486B-9A72-C5F9C2DAC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778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67B98D5-A1A9-428C-8396-6DEE033F59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836F68E-F4BB-417A-8494-1C02185DAB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D660B1-2F13-4462-965C-410A694FC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645C83-F727-4269-9823-55353F925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6D4757B-4924-427D-B3DD-1EDCE20A5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17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EDD90BF-D5CA-4083-8F05-3A9902EEAD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B94A143-6BCA-45F5-BDF7-6DCDFB172B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4588EB2-15BD-4A19-AE71-54936E6C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32B4FA-E82E-499C-938E-228E64939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A0379C-D202-4156-AF89-BCECBF332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3524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80D957-2FEE-4169-874E-4417FBF128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766ABDD-1B7B-46BA-AC98-7EE712A5A7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666668C-B785-4673-B1FF-0EE2A81A7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0D035E-1C7A-4884-B3E2-115217F06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7200E4-0F71-4096-AA0F-7B838AA41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3180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DBD7C4-09D3-4B70-8543-695D526240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A898782-AD1E-4096-A90D-52DFDAD08F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F32414-ECE6-41E7-B098-B53D752BB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E069674-DA4D-4694-94FB-88C40F291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03DC3DF-340D-49BB-B4DD-F631E5E82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1777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D6D724-BC1F-4F5E-8443-12172DC4E4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283E192-9A6C-47B4-B531-DC0A854161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B83921F-C0D9-4CAE-A7AA-744CF5BCFC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9CBCA8E-53CF-4A33-A09B-8834043FA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FEE35F9-7B63-469C-BD39-6062C5F97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6E4897A-B93C-4E11-881A-9007921B9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3412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BDCAF1-31A5-4FF9-B0E4-64507FB129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557FEAE-0BAD-4A19-8EEA-EFC51E1F8E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A12F2D3-30F0-4B51-99AC-63C26EB1C4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F74A9EC-616D-45E7-A810-FD3F75827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E58DEBD-89FD-4A8E-A828-AB5A1E2467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9ACD865-3B53-47BF-9AEC-7153604DD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28FF13A-5DD3-4E1A-B8FD-854E69A46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A39BE27-58B5-4C42-8898-8C31ED1B3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9505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69C002-43F2-4861-9BFF-70EEB312D4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5C3850E-4EC5-49CF-B9AF-5010E115B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FD433DA-6A78-4C06-8931-C397AA94F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30EE694-600F-4EC7-B042-EE572D569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8099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468EA59-730F-4107-9D46-CBD0E82F4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2EE9B5B-2B32-4B8B-BA67-923371F2BB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14EB848-3ED7-47C9-BDF2-78A77B215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1148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9A9646-7FB5-4E2E-BAF6-467B8A959A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02A6D8A-E4AD-4BDD-9CA6-4636A077B3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64E599E-FB0B-40AA-9EB4-6844A0DC05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F5A880E-3039-4180-B0DD-4542F35AE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39099E3-EB4A-49A2-A218-7E06ED3D7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D1CD9A3-B373-4318-AD31-4544825B9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4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E05F55-6965-4C4B-8DE6-16D16321CE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324DA2D-2060-4E6B-B7C0-48F00B883C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AC20290-7782-4E2C-B50A-2BDF88068B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A966438-A399-49F2-85E8-84D306773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1017AA6-F95E-47A4-9D08-EA0D378E51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F59A3B8-6E98-47DD-8603-89973A052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44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0B51FD4-C5F3-4025-BF3F-8201135BC3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23DA574-841B-4C78-A341-CF5144022E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AD69F1-D4AA-4324-AB04-5C4FD7F0CC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A86698-E36F-4FFB-8533-D2B12F75BD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A7A8DF-5D73-4F7A-A174-D53BD1166D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320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51564A6A-EE57-49B0-B295-AAC447F8597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7" t="9466" r="715" b="22655"/>
          <a:stretch/>
        </p:blipFill>
        <p:spPr>
          <a:xfrm>
            <a:off x="65314" y="1397329"/>
            <a:ext cx="12061372" cy="465512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DBBC747-CCB2-4203-84C5-0A286D4EE9AA}"/>
              </a:ext>
            </a:extLst>
          </p:cNvPr>
          <p:cNvSpPr txBox="1"/>
          <p:nvPr/>
        </p:nvSpPr>
        <p:spPr>
          <a:xfrm>
            <a:off x="839189" y="663039"/>
            <a:ext cx="2310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tumor </a:t>
            </a:r>
            <a:r>
              <a:rPr lang="en-US" altLang="ja-JP" b="1" dirty="0"/>
              <a:t>RNase-p 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34535044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FA624A7A-9E12-4F26-935F-BAB2798EF76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2" t="9639" r="389" b="22136"/>
          <a:stretch/>
        </p:blipFill>
        <p:spPr>
          <a:xfrm>
            <a:off x="83127" y="1547751"/>
            <a:ext cx="12108873" cy="4678878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9C9A42C-3F60-44BB-BD50-CFA29101C499}"/>
              </a:ext>
            </a:extLst>
          </p:cNvPr>
          <p:cNvSpPr txBox="1"/>
          <p:nvPr/>
        </p:nvSpPr>
        <p:spPr>
          <a:xfrm>
            <a:off x="1223158" y="718457"/>
            <a:ext cx="3284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tumor KIAA1549-BRAF 3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33342408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E4928A7A-26B5-47D1-9A26-ED3ED78AD7D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22" t="9351" r="390" b="22771"/>
          <a:stretch/>
        </p:blipFill>
        <p:spPr>
          <a:xfrm>
            <a:off x="49480" y="1417123"/>
            <a:ext cx="12093039" cy="4655127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0626EF0-3C81-4D20-891C-4FCE4E01535F}"/>
              </a:ext>
            </a:extLst>
          </p:cNvPr>
          <p:cNvSpPr txBox="1"/>
          <p:nvPr/>
        </p:nvSpPr>
        <p:spPr>
          <a:xfrm>
            <a:off x="1223158" y="718457"/>
            <a:ext cx="3156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MVP KIAA1549-BRAF 3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395147645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47ABE41-2C10-42E7-9B9E-4D95B0BABB14}"/>
              </a:ext>
            </a:extLst>
          </p:cNvPr>
          <p:cNvSpPr txBox="1"/>
          <p:nvPr/>
        </p:nvSpPr>
        <p:spPr>
          <a:xfrm>
            <a:off x="1223158" y="718457"/>
            <a:ext cx="3938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tumor/MVP KIAA1549-BRAF 3</a:t>
            </a:r>
            <a:endParaRPr kumimoji="1" lang="ja-JP" altLang="en-US" b="1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BE44C5B-7E17-41AE-9653-53D4CFEF6E5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4" t="9351" r="585" b="20981"/>
          <a:stretch/>
        </p:blipFill>
        <p:spPr>
          <a:xfrm>
            <a:off x="63335" y="1361705"/>
            <a:ext cx="12065330" cy="4777838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2DFE3D6-7AE6-424E-8A27-599E4D1A5B0B}"/>
              </a:ext>
            </a:extLst>
          </p:cNvPr>
          <p:cNvSpPr/>
          <p:nvPr/>
        </p:nvSpPr>
        <p:spPr>
          <a:xfrm>
            <a:off x="6096000" y="3855521"/>
            <a:ext cx="1417122" cy="22958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8A3387F7-D31E-4F57-97A2-56F9F1ECE755}"/>
              </a:ext>
            </a:extLst>
          </p:cNvPr>
          <p:cNvSpPr/>
          <p:nvPr/>
        </p:nvSpPr>
        <p:spPr>
          <a:xfrm>
            <a:off x="6096000" y="4399806"/>
            <a:ext cx="1417122" cy="229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9251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0BCA27FC-618D-49F8-B36F-521C3506E6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380410"/>
              </p:ext>
            </p:extLst>
          </p:nvPr>
        </p:nvGraphicFramePr>
        <p:xfrm>
          <a:off x="323352" y="2591030"/>
          <a:ext cx="11545296" cy="1854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24216">
                  <a:extLst>
                    <a:ext uri="{9D8B030D-6E8A-4147-A177-3AD203B41FA5}">
                      <a16:colId xmlns:a16="http://schemas.microsoft.com/office/drawing/2014/main" val="922732477"/>
                    </a:ext>
                  </a:extLst>
                </a:gridCol>
                <a:gridCol w="1924216">
                  <a:extLst>
                    <a:ext uri="{9D8B030D-6E8A-4147-A177-3AD203B41FA5}">
                      <a16:colId xmlns:a16="http://schemas.microsoft.com/office/drawing/2014/main" val="3094276893"/>
                    </a:ext>
                  </a:extLst>
                </a:gridCol>
                <a:gridCol w="1924216">
                  <a:extLst>
                    <a:ext uri="{9D8B030D-6E8A-4147-A177-3AD203B41FA5}">
                      <a16:colId xmlns:a16="http://schemas.microsoft.com/office/drawing/2014/main" val="2507284571"/>
                    </a:ext>
                  </a:extLst>
                </a:gridCol>
                <a:gridCol w="1924216">
                  <a:extLst>
                    <a:ext uri="{9D8B030D-6E8A-4147-A177-3AD203B41FA5}">
                      <a16:colId xmlns:a16="http://schemas.microsoft.com/office/drawing/2014/main" val="1961806223"/>
                    </a:ext>
                  </a:extLst>
                </a:gridCol>
                <a:gridCol w="1924216">
                  <a:extLst>
                    <a:ext uri="{9D8B030D-6E8A-4147-A177-3AD203B41FA5}">
                      <a16:colId xmlns:a16="http://schemas.microsoft.com/office/drawing/2014/main" val="465009027"/>
                    </a:ext>
                  </a:extLst>
                </a:gridCol>
                <a:gridCol w="1924216">
                  <a:extLst>
                    <a:ext uri="{9D8B030D-6E8A-4147-A177-3AD203B41FA5}">
                      <a16:colId xmlns:a16="http://schemas.microsoft.com/office/drawing/2014/main" val="3466714734"/>
                    </a:ext>
                  </a:extLst>
                </a:gridCol>
              </a:tblGrid>
              <a:tr h="370840"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Tumor</a:t>
                      </a:r>
                      <a:endParaRPr kumimoji="1" lang="ja-JP" altLang="en-US" dirty="0"/>
                    </a:p>
                  </a:txBody>
                  <a:tcPr>
                    <a:solidFill>
                      <a:srgbClr val="00B0F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dirty="0"/>
                    </a:p>
                  </a:txBody>
                  <a:tcPr>
                    <a:solidFill>
                      <a:srgbClr val="00B0F0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MVP</a:t>
                      </a:r>
                      <a:endParaRPr kumimoji="1" lang="ja-JP" altLang="en-US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80433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="1" dirty="0"/>
                        <a:t>RNase-P </a:t>
                      </a:r>
                      <a:r>
                        <a:rPr kumimoji="1" lang="en-US" altLang="ja-JP" sz="1000" b="1" dirty="0"/>
                        <a:t>(copies/</a:t>
                      </a:r>
                      <a:r>
                        <a:rPr kumimoji="1" lang="en-US" altLang="ja-JP" sz="1000" b="1" dirty="0" err="1"/>
                        <a:t>ul</a:t>
                      </a:r>
                      <a:r>
                        <a:rPr kumimoji="1" lang="en-US" altLang="ja-JP" sz="1000" b="1" dirty="0"/>
                        <a:t>)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1" dirty="0"/>
                        <a:t>KIAA-BRAF</a:t>
                      </a:r>
                      <a:r>
                        <a:rPr kumimoji="1" lang="en-US" altLang="ja-JP" sz="1600" b="1" dirty="0"/>
                        <a:t> </a:t>
                      </a:r>
                      <a:r>
                        <a:rPr kumimoji="1" lang="en-US" altLang="ja-JP" sz="1000" b="1" dirty="0"/>
                        <a:t>(copies/</a:t>
                      </a:r>
                      <a:r>
                        <a:rPr kumimoji="1" lang="en-US" altLang="ja-JP" sz="1000" b="1" dirty="0" err="1"/>
                        <a:t>ul</a:t>
                      </a:r>
                      <a:r>
                        <a:rPr kumimoji="1" lang="en-US" altLang="ja-JP" sz="1000" b="1" dirty="0"/>
                        <a:t>)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/>
                        <a:t>KIAA-BRAF/RNase</a:t>
                      </a:r>
                      <a:endParaRPr kumimoji="1" lang="ja-JP" altLang="en-US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/>
                        <a:t>RNase-P </a:t>
                      </a:r>
                      <a:r>
                        <a:rPr kumimoji="1" lang="en-US" altLang="ja-JP" sz="1000" b="1" dirty="0"/>
                        <a:t>(copies/</a:t>
                      </a:r>
                      <a:r>
                        <a:rPr kumimoji="1" lang="en-US" altLang="ja-JP" sz="1000" b="1" dirty="0" err="1"/>
                        <a:t>ul</a:t>
                      </a:r>
                      <a:r>
                        <a:rPr kumimoji="1" lang="en-US" altLang="ja-JP" sz="1000" b="1" dirty="0"/>
                        <a:t>)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1" dirty="0"/>
                        <a:t>KIAA-BRAF</a:t>
                      </a:r>
                      <a:r>
                        <a:rPr kumimoji="1" lang="en-US" altLang="ja-JP" sz="1600" b="1" dirty="0"/>
                        <a:t> </a:t>
                      </a:r>
                      <a:r>
                        <a:rPr kumimoji="1" lang="en-US" altLang="ja-JP" sz="1000" b="1" dirty="0"/>
                        <a:t>(copies/</a:t>
                      </a:r>
                      <a:r>
                        <a:rPr kumimoji="1" lang="en-US" altLang="ja-JP" sz="1000" b="1" dirty="0" err="1"/>
                        <a:t>ul</a:t>
                      </a:r>
                      <a:r>
                        <a:rPr kumimoji="1" lang="en-US" altLang="ja-JP" sz="1000" b="1" dirty="0"/>
                        <a:t>)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/>
                        <a:t>KIAA-BRAF/RNase</a:t>
                      </a:r>
                      <a:endParaRPr kumimoji="1" lang="ja-JP" altLang="en-US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40235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5.409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.685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174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5.807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.779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176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78248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.18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206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.767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175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906835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.843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185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.246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079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5139638"/>
                  </a:ext>
                </a:extLst>
              </a:tr>
            </a:tbl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7CFA541-89E2-40AC-8322-E752E4864300}"/>
              </a:ext>
            </a:extLst>
          </p:cNvPr>
          <p:cNvSpPr txBox="1"/>
          <p:nvPr/>
        </p:nvSpPr>
        <p:spPr>
          <a:xfrm>
            <a:off x="1492332" y="1490354"/>
            <a:ext cx="89514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Expression of KIAA1549-BRAF and RNase-P in S6 samples</a:t>
            </a:r>
            <a:endParaRPr kumimoji="1" lang="ja-JP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3542200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DB52E63-C6C6-4869-B851-4E8EEA870AE1}"/>
              </a:ext>
            </a:extLst>
          </p:cNvPr>
          <p:cNvSpPr txBox="1"/>
          <p:nvPr/>
        </p:nvSpPr>
        <p:spPr>
          <a:xfrm>
            <a:off x="839189" y="663039"/>
            <a:ext cx="21820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MVP </a:t>
            </a:r>
            <a:r>
              <a:rPr lang="en-US" altLang="ja-JP" b="1" dirty="0"/>
              <a:t>RNase-p </a:t>
            </a:r>
            <a:endParaRPr kumimoji="1" lang="ja-JP" altLang="en-US" b="1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8B8F39E2-A02A-4BB2-9235-F5AF97B9545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8" t="9668" r="811" b="23406"/>
          <a:stretch/>
        </p:blipFill>
        <p:spPr>
          <a:xfrm>
            <a:off x="63334" y="1430976"/>
            <a:ext cx="12065331" cy="45898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66873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F8EDD77C-DE75-457B-AE44-3A4295FB7E9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52" t="9524" r="356" b="20173"/>
          <a:stretch/>
        </p:blipFill>
        <p:spPr>
          <a:xfrm>
            <a:off x="55418" y="1357744"/>
            <a:ext cx="12081163" cy="4821383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2CA844B-C806-42BB-B6D3-70D73AA84C83}"/>
              </a:ext>
            </a:extLst>
          </p:cNvPr>
          <p:cNvSpPr txBox="1"/>
          <p:nvPr/>
        </p:nvSpPr>
        <p:spPr>
          <a:xfrm>
            <a:off x="839189" y="663039"/>
            <a:ext cx="2964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tumor/MVP </a:t>
            </a:r>
            <a:r>
              <a:rPr lang="en-US" altLang="ja-JP" b="1" dirty="0"/>
              <a:t>RNase-p </a:t>
            </a:r>
            <a:endParaRPr kumimoji="1" lang="ja-JP" altLang="en-US" b="1" dirty="0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EF2F2A25-779F-4267-87CC-8529E87F1A43}"/>
              </a:ext>
            </a:extLst>
          </p:cNvPr>
          <p:cNvSpPr/>
          <p:nvPr/>
        </p:nvSpPr>
        <p:spPr>
          <a:xfrm>
            <a:off x="6096000" y="4564083"/>
            <a:ext cx="1417122" cy="22958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8904FA30-4D46-418B-8F25-01FB2B106051}"/>
              </a:ext>
            </a:extLst>
          </p:cNvPr>
          <p:cNvSpPr/>
          <p:nvPr/>
        </p:nvSpPr>
        <p:spPr>
          <a:xfrm>
            <a:off x="6096000" y="5108368"/>
            <a:ext cx="1417122" cy="229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8853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3BF9E993-5AEF-4497-B1F7-6B956EE8A34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7" t="9351" r="1006" b="22828"/>
          <a:stretch/>
        </p:blipFill>
        <p:spPr>
          <a:xfrm>
            <a:off x="43543" y="1060863"/>
            <a:ext cx="12025746" cy="465116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7CC91E1-A4D5-4170-839B-5283B6B14344}"/>
              </a:ext>
            </a:extLst>
          </p:cNvPr>
          <p:cNvSpPr txBox="1"/>
          <p:nvPr/>
        </p:nvSpPr>
        <p:spPr>
          <a:xfrm>
            <a:off x="839189" y="476992"/>
            <a:ext cx="3284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tumor </a:t>
            </a:r>
            <a:r>
              <a:rPr lang="en-US" altLang="ja-JP" b="1" dirty="0"/>
              <a:t>KIAA1549-BRAF </a:t>
            </a:r>
            <a:r>
              <a:rPr kumimoji="1" lang="en-US" altLang="ja-JP" b="1" dirty="0"/>
              <a:t>1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11392300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D8B509B2-F0EE-4B7C-ACA7-0259D985B1F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91" t="9235" r="454" b="23406"/>
          <a:stretch/>
        </p:blipFill>
        <p:spPr>
          <a:xfrm>
            <a:off x="51459" y="1421081"/>
            <a:ext cx="12089082" cy="4619502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98DF79E-AE12-4ABF-81F9-0763050B5605}"/>
              </a:ext>
            </a:extLst>
          </p:cNvPr>
          <p:cNvSpPr txBox="1"/>
          <p:nvPr/>
        </p:nvSpPr>
        <p:spPr>
          <a:xfrm>
            <a:off x="1223158" y="718457"/>
            <a:ext cx="3156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MVP </a:t>
            </a:r>
            <a:r>
              <a:rPr lang="en-US" altLang="ja-JP" b="1" dirty="0"/>
              <a:t>KIAA1549-BRAF </a:t>
            </a:r>
            <a:r>
              <a:rPr kumimoji="1" lang="en-US" altLang="ja-JP" b="1" dirty="0"/>
              <a:t>1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3378718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D2B8E72-6D03-4121-ADDB-7A222684BAE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25" t="9640" r="1039" b="21500"/>
          <a:stretch/>
        </p:blipFill>
        <p:spPr>
          <a:xfrm>
            <a:off x="110836" y="1417122"/>
            <a:ext cx="12025746" cy="4722421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B62BF6A-A24D-4F04-BDE9-6D5135275125}"/>
              </a:ext>
            </a:extLst>
          </p:cNvPr>
          <p:cNvSpPr/>
          <p:nvPr/>
        </p:nvSpPr>
        <p:spPr>
          <a:xfrm>
            <a:off x="6167252" y="4975761"/>
            <a:ext cx="1417122" cy="22958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316D09CF-988D-4947-B4A5-1949F47C84BB}"/>
              </a:ext>
            </a:extLst>
          </p:cNvPr>
          <p:cNvSpPr/>
          <p:nvPr/>
        </p:nvSpPr>
        <p:spPr>
          <a:xfrm>
            <a:off x="6167252" y="5520046"/>
            <a:ext cx="1417122" cy="229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E898DFC-3AAE-4BED-9814-BF4156D545D8}"/>
              </a:ext>
            </a:extLst>
          </p:cNvPr>
          <p:cNvSpPr txBox="1"/>
          <p:nvPr/>
        </p:nvSpPr>
        <p:spPr>
          <a:xfrm>
            <a:off x="1223158" y="718457"/>
            <a:ext cx="3938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tumor/MVP KIAA1549-BRAF 1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691329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F8EEC5E5-357C-487C-908B-CF22D49706F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292" r="259" b="22078"/>
          <a:stretch/>
        </p:blipFill>
        <p:spPr>
          <a:xfrm>
            <a:off x="159018" y="1432956"/>
            <a:ext cx="11873964" cy="4595751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BF2BAE8-C686-458B-9054-1476735D23DA}"/>
              </a:ext>
            </a:extLst>
          </p:cNvPr>
          <p:cNvSpPr txBox="1"/>
          <p:nvPr/>
        </p:nvSpPr>
        <p:spPr>
          <a:xfrm>
            <a:off x="1223158" y="718457"/>
            <a:ext cx="3284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tumor KIAA1549-BRAF 2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251725420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792D125E-A42F-47D5-A31C-BCA9D906AB3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46" t="9524" r="325" b="22655"/>
          <a:stretch/>
        </p:blipFill>
        <p:spPr>
          <a:xfrm>
            <a:off x="65314" y="1428998"/>
            <a:ext cx="12061372" cy="465117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10A70CC-8545-4C01-A62C-0A4BE4E81A81}"/>
              </a:ext>
            </a:extLst>
          </p:cNvPr>
          <p:cNvSpPr txBox="1"/>
          <p:nvPr/>
        </p:nvSpPr>
        <p:spPr>
          <a:xfrm>
            <a:off x="1223158" y="718457"/>
            <a:ext cx="3156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MVP KIAA1549-BRAF 2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6513367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34869EF6-9288-4758-AFA7-BF3377258EC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8" t="9409" r="422" b="20461"/>
          <a:stretch/>
        </p:blipFill>
        <p:spPr>
          <a:xfrm>
            <a:off x="39584" y="1527958"/>
            <a:ext cx="12112832" cy="4809506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7A43AEB-C77E-451A-9C06-DAA6906C9203}"/>
              </a:ext>
            </a:extLst>
          </p:cNvPr>
          <p:cNvSpPr txBox="1"/>
          <p:nvPr/>
        </p:nvSpPr>
        <p:spPr>
          <a:xfrm>
            <a:off x="1223158" y="718457"/>
            <a:ext cx="3938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tumor/MVP KIAA1549-BRAF 2</a:t>
            </a:r>
            <a:endParaRPr kumimoji="1" lang="ja-JP" altLang="en-US" b="1" dirty="0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4B1E0308-A123-48C9-80CE-34798D315DB9}"/>
              </a:ext>
            </a:extLst>
          </p:cNvPr>
          <p:cNvSpPr/>
          <p:nvPr/>
        </p:nvSpPr>
        <p:spPr>
          <a:xfrm>
            <a:off x="6068291" y="5062846"/>
            <a:ext cx="1417122" cy="22958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C171A6A-3C2F-466F-9B28-BFDAA527D37C}"/>
              </a:ext>
            </a:extLst>
          </p:cNvPr>
          <p:cNvSpPr/>
          <p:nvPr/>
        </p:nvSpPr>
        <p:spPr>
          <a:xfrm>
            <a:off x="6068291" y="5607131"/>
            <a:ext cx="1417122" cy="229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207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107</Words>
  <Application>Microsoft Office PowerPoint</Application>
  <PresentationFormat>ワイド画面</PresentationFormat>
  <Paragraphs>35</Paragraphs>
  <Slides>1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3</vt:i4>
      </vt:variant>
    </vt:vector>
  </HeadingPairs>
  <TitlesOfParts>
    <vt:vector size="17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ji</dc:creator>
  <cp:lastModifiedBy>Shinji</cp:lastModifiedBy>
  <cp:revision>6</cp:revision>
  <dcterms:created xsi:type="dcterms:W3CDTF">2019-04-16T03:17:59Z</dcterms:created>
  <dcterms:modified xsi:type="dcterms:W3CDTF">2019-04-16T04:02:55Z</dcterms:modified>
</cp:coreProperties>
</file>